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6"/>
  </p:notesMasterIdLst>
  <p:sldIdLst>
    <p:sldId id="1133" r:id="rId2"/>
    <p:sldId id="1134" r:id="rId3"/>
    <p:sldId id="1135" r:id="rId4"/>
    <p:sldId id="1136" r:id="rId5"/>
  </p:sldIdLst>
  <p:sldSz cx="12192000" cy="16256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5AB1C69-6EDB-4FF4-983F-18BD219EF322}" styleName="中間スタイル 2 - アクセント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465" autoAdjust="0"/>
    <p:restoredTop sz="94660"/>
  </p:normalViewPr>
  <p:slideViewPr>
    <p:cSldViewPr snapToGrid="0">
      <p:cViewPr varScale="1">
        <p:scale>
          <a:sx n="36" d="100"/>
          <a:sy n="36" d="100"/>
        </p:scale>
        <p:origin x="2458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85454A9-5C33-48EF-9FFF-ECAA0FF5D96A}" type="datetimeFigureOut">
              <a:rPr kumimoji="1" lang="ja-JP" altLang="en-US" smtClean="0"/>
              <a:t>2021/9/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9798E99-9A4D-4298-A02E-770372BDCA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0522886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660416"/>
            <a:ext cx="10363200" cy="5659496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8538164"/>
            <a:ext cx="9144000" cy="3924769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56A42E-8077-4FA2-BE6A-6F634C484408}" type="datetimeFigureOut">
              <a:rPr kumimoji="1" lang="ja-JP" altLang="en-US" smtClean="0"/>
              <a:t>2021/9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E446A-F03D-48AE-A3DD-8A95C187221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96348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56A42E-8077-4FA2-BE6A-6F634C484408}" type="datetimeFigureOut">
              <a:rPr kumimoji="1" lang="ja-JP" altLang="en-US" smtClean="0"/>
              <a:t>2021/9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E446A-F03D-48AE-A3DD-8A95C187221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819091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865481"/>
            <a:ext cx="2628900" cy="13776209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865481"/>
            <a:ext cx="7734300" cy="13776209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56A42E-8077-4FA2-BE6A-6F634C484408}" type="datetimeFigureOut">
              <a:rPr kumimoji="1" lang="ja-JP" altLang="en-US" smtClean="0"/>
              <a:t>2021/9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E446A-F03D-48AE-A3DD-8A95C187221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124654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56A42E-8077-4FA2-BE6A-6F634C484408}" type="datetimeFigureOut">
              <a:rPr kumimoji="1" lang="ja-JP" altLang="en-US" smtClean="0"/>
              <a:t>2021/9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E446A-F03D-48AE-A3DD-8A95C187221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173541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052716"/>
            <a:ext cx="10515600" cy="6762043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0878731"/>
            <a:ext cx="10515600" cy="355599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56A42E-8077-4FA2-BE6A-6F634C484408}" type="datetimeFigureOut">
              <a:rPr kumimoji="1" lang="ja-JP" altLang="en-US" smtClean="0"/>
              <a:t>2021/9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E446A-F03D-48AE-A3DD-8A95C187221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198140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327407"/>
            <a:ext cx="5181600" cy="103142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327407"/>
            <a:ext cx="5181600" cy="103142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56A42E-8077-4FA2-BE6A-6F634C484408}" type="datetimeFigureOut">
              <a:rPr kumimoji="1" lang="ja-JP" altLang="en-US" smtClean="0"/>
              <a:t>2021/9/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E446A-F03D-48AE-A3DD-8A95C187221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249137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65485"/>
            <a:ext cx="10515600" cy="3142075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984979"/>
            <a:ext cx="5157787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937956"/>
            <a:ext cx="5157787" cy="87338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984979"/>
            <a:ext cx="5183188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937956"/>
            <a:ext cx="5183188" cy="87338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56A42E-8077-4FA2-BE6A-6F634C484408}" type="datetimeFigureOut">
              <a:rPr kumimoji="1" lang="ja-JP" altLang="en-US" smtClean="0"/>
              <a:t>2021/9/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E446A-F03D-48AE-A3DD-8A95C187221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065534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56A42E-8077-4FA2-BE6A-6F634C484408}" type="datetimeFigureOut">
              <a:rPr kumimoji="1" lang="ja-JP" altLang="en-US" smtClean="0"/>
              <a:t>2021/9/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E446A-F03D-48AE-A3DD-8A95C187221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107263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56A42E-8077-4FA2-BE6A-6F634C484408}" type="datetimeFigureOut">
              <a:rPr kumimoji="1" lang="ja-JP" altLang="en-US" smtClean="0"/>
              <a:t>2021/9/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E446A-F03D-48AE-A3DD-8A95C187221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703286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340567"/>
            <a:ext cx="6172200" cy="1155229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56A42E-8077-4FA2-BE6A-6F634C484408}" type="datetimeFigureOut">
              <a:rPr kumimoji="1" lang="ja-JP" altLang="en-US" smtClean="0"/>
              <a:t>2021/9/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E446A-F03D-48AE-A3DD-8A95C187221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235499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340567"/>
            <a:ext cx="6172200" cy="1155229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56A42E-8077-4FA2-BE6A-6F634C484408}" type="datetimeFigureOut">
              <a:rPr kumimoji="1" lang="ja-JP" altLang="en-US" smtClean="0"/>
              <a:t>2021/9/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E446A-F03D-48AE-A3DD-8A95C187221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415493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327407"/>
            <a:ext cx="10515600" cy="103142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56A42E-8077-4FA2-BE6A-6F634C484408}" type="datetimeFigureOut">
              <a:rPr kumimoji="1" lang="ja-JP" altLang="en-US" smtClean="0"/>
              <a:t>2021/9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FE446A-F03D-48AE-A3DD-8A95C187221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985371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kumimoji="1"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kumimoji="1"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9.emf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表 2">
            <a:extLst>
              <a:ext uri="{FF2B5EF4-FFF2-40B4-BE49-F238E27FC236}">
                <a16:creationId xmlns:a16="http://schemas.microsoft.com/office/drawing/2014/main" id="{E1AAFDBE-6313-4C3C-AC1B-DB3B3B32A55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37456005"/>
              </p:ext>
            </p:extLst>
          </p:nvPr>
        </p:nvGraphicFramePr>
        <p:xfrm>
          <a:off x="305094" y="913211"/>
          <a:ext cx="10731205" cy="8654587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860901">
                  <a:extLst>
                    <a:ext uri="{9D8B030D-6E8A-4147-A177-3AD203B41FA5}">
                      <a16:colId xmlns:a16="http://schemas.microsoft.com/office/drawing/2014/main" val="444079962"/>
                    </a:ext>
                  </a:extLst>
                </a:gridCol>
                <a:gridCol w="2822634">
                  <a:extLst>
                    <a:ext uri="{9D8B030D-6E8A-4147-A177-3AD203B41FA5}">
                      <a16:colId xmlns:a16="http://schemas.microsoft.com/office/drawing/2014/main" val="835315211"/>
                    </a:ext>
                  </a:extLst>
                </a:gridCol>
                <a:gridCol w="2999048">
                  <a:extLst>
                    <a:ext uri="{9D8B030D-6E8A-4147-A177-3AD203B41FA5}">
                      <a16:colId xmlns:a16="http://schemas.microsoft.com/office/drawing/2014/main" val="3566343448"/>
                    </a:ext>
                  </a:extLst>
                </a:gridCol>
                <a:gridCol w="3048622">
                  <a:extLst>
                    <a:ext uri="{9D8B030D-6E8A-4147-A177-3AD203B41FA5}">
                      <a16:colId xmlns:a16="http://schemas.microsoft.com/office/drawing/2014/main" val="2605092248"/>
                    </a:ext>
                  </a:extLst>
                </a:gridCol>
              </a:tblGrid>
              <a:tr h="399312">
                <a:tc>
                  <a:txBody>
                    <a:bodyPr/>
                    <a:lstStyle/>
                    <a:p>
                      <a:pPr algn="ctr"/>
                      <a:endParaRPr kumimoji="1" lang="ja-JP" altLang="en-US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ype 1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ype 2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ype</a:t>
                      </a:r>
                      <a:r>
                        <a:rPr kumimoji="1" lang="ja-JP" altLang="en-US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68776682"/>
                  </a:ext>
                </a:extLst>
              </a:tr>
              <a:tr h="864789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lor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me or lighter than background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>
                          <a:srgbClr val="000000"/>
                        </a:buClr>
                        <a:buSzPct val="100000"/>
                        <a:buFont typeface="Arial" pitchFamily="1" charset="0"/>
                        <a:buNone/>
                        <a:tabLst>
                          <a:tab pos="1244600" algn="l"/>
                          <a:tab pos="1828800" algn="l"/>
                        </a:tabLst>
                      </a:pPr>
                      <a:r>
                        <a:rPr kumimoji="0" lang="en-US" altLang="ja-JP" sz="16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itchFamily="1" charset="0"/>
                          <a:cs typeface="Times New Roman" panose="02020603050405020304" pitchFamily="18" charset="0"/>
                          <a:sym typeface="Calibri" pitchFamily="1" charset="0"/>
                        </a:rPr>
                        <a:t>Browner relative to background (verify color arises from vessels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own to dark brown relative to background; sometimes patchy whiter areas</a:t>
                      </a:r>
                      <a:endParaRPr kumimoji="1" lang="ja-JP" altLang="en-US" sz="16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45403526"/>
                  </a:ext>
                </a:extLst>
              </a:tr>
              <a:tr h="85090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essels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21917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ja-JP" sz="16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itchFamily="1" charset="0"/>
                          <a:cs typeface="Times New Roman" panose="02020603050405020304" pitchFamily="18" charset="0"/>
                          <a:sym typeface="Calibri" pitchFamily="1" charset="0"/>
                        </a:rPr>
                        <a:t>None, or isolated lacy vessels may be present coursing across the lesion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21917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ja-JP" sz="16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itchFamily="1" charset="0"/>
                          <a:cs typeface="Times New Roman" panose="02020603050405020304" pitchFamily="18" charset="0"/>
                          <a:sym typeface="Calibri" pitchFamily="1" charset="0"/>
                        </a:rPr>
                        <a:t>Brown vessels surrounding white structures</a:t>
                      </a:r>
                      <a:r>
                        <a:rPr kumimoji="1" lang="en-US" altLang="ja-JP" sz="16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  <a:r>
                        <a:rPr kumimoji="1" lang="en-US" altLang="ja-JP" sz="1600" b="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kumimoji="1" lang="ja-JP" altLang="en-US" sz="16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as area(s) with disrupted or missing vessels</a:t>
                      </a:r>
                      <a:endParaRPr kumimoji="1" lang="ja-JP" altLang="en-US" sz="16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45754433"/>
                  </a:ext>
                </a:extLst>
              </a:tr>
              <a:tr h="100330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rface pattern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>
                          <a:srgbClr val="000000"/>
                        </a:buClr>
                        <a:buSzPct val="100000"/>
                        <a:buFont typeface="Arial" pitchFamily="1" charset="0"/>
                        <a:buNone/>
                        <a:tabLst>
                          <a:tab pos="1244600" algn="l"/>
                          <a:tab pos="1828800" algn="l"/>
                        </a:tabLst>
                      </a:pPr>
                      <a:r>
                        <a:rPr kumimoji="0" lang="en-US" altLang="ja-JP" sz="16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itchFamily="1" charset="0"/>
                          <a:cs typeface="Times New Roman" panose="02020603050405020304" pitchFamily="18" charset="0"/>
                          <a:sym typeface="Calibri" pitchFamily="1" charset="0"/>
                        </a:rPr>
                        <a:t>Dark or white spots of uniform size, or homogenous absence of pattern 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>
                          <a:srgbClr val="000000"/>
                        </a:buClr>
                        <a:buSzPct val="100000"/>
                        <a:buFont typeface="Arial" pitchFamily="1" charset="0"/>
                        <a:buNone/>
                        <a:tabLst>
                          <a:tab pos="1244600" algn="l"/>
                          <a:tab pos="1828800" algn="l"/>
                        </a:tabLst>
                      </a:pPr>
                      <a:r>
                        <a:rPr kumimoji="0" lang="en-US" altLang="ja-JP" sz="16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itchFamily="1" charset="0"/>
                          <a:cs typeface="Times New Roman" panose="02020603050405020304" pitchFamily="18" charset="0"/>
                          <a:sym typeface="Calibri" pitchFamily="1" charset="0"/>
                        </a:rPr>
                        <a:t>Oval, tubular or branched  white structures*</a:t>
                      </a:r>
                      <a:r>
                        <a:rPr kumimoji="0" lang="en-US" altLang="ja-JP" sz="1600" b="0" i="0" u="none" strike="noStrike" cap="none" normalizeH="0" baseline="3000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itchFamily="1" charset="0"/>
                          <a:cs typeface="Times New Roman" panose="02020603050405020304" pitchFamily="18" charset="0"/>
                          <a:sym typeface="Calibri" pitchFamily="1" charset="0"/>
                        </a:rPr>
                        <a:t>2 </a:t>
                      </a:r>
                      <a:r>
                        <a:rPr kumimoji="0" lang="en-US" altLang="ja-JP" sz="16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itchFamily="1" charset="0"/>
                          <a:cs typeface="Times New Roman" panose="02020603050405020304" pitchFamily="18" charset="0"/>
                          <a:sym typeface="Calibri" pitchFamily="1" charset="0"/>
                        </a:rPr>
                        <a:t>surrounded by brown vessels 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morphous or absence surface pattern</a:t>
                      </a:r>
                      <a:endParaRPr kumimoji="1" lang="ja-JP" altLang="en-US" sz="16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42012251"/>
                  </a:ext>
                </a:extLst>
              </a:tr>
              <a:tr h="100330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st likely pathology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yperplastic</a:t>
                      </a:r>
                      <a:r>
                        <a:rPr kumimoji="1" lang="ja-JP" altLang="en-US" sz="16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en-US" altLang="ja-JP" sz="16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amp; Sessile serrated polyp*</a:t>
                      </a:r>
                      <a:r>
                        <a:rPr kumimoji="1" lang="en-US" altLang="ja-JP" sz="1600" baseline="30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kumimoji="1" lang="ja-JP" altLang="en-US" sz="1600" baseline="30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denoma</a:t>
                      </a:r>
                      <a:r>
                        <a:rPr kumimoji="1" lang="en-US" altLang="ja-JP" sz="16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  <a:r>
                        <a:rPr kumimoji="1" lang="en-US" altLang="ja-JP" sz="1600" b="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kumimoji="1" lang="ja-JP" altLang="en-US" sz="16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ep submucosal invasive cancer</a:t>
                      </a:r>
                      <a:endParaRPr kumimoji="1" lang="ja-JP" altLang="en-US" sz="16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4473022"/>
                  </a:ext>
                </a:extLst>
              </a:tr>
              <a:tr h="2237549">
                <a:tc rowSpan="2"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ndoscopic image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16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16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16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16240594"/>
                  </a:ext>
                </a:extLst>
              </a:tr>
              <a:tr h="2237549">
                <a:tc vMerge="1">
                  <a:txBody>
                    <a:bodyPr/>
                    <a:lstStyle/>
                    <a:p>
                      <a:pPr algn="ctr"/>
                      <a:endParaRPr kumimoji="1" lang="ja-JP" altLang="en-US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16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16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16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21479587"/>
                  </a:ext>
                </a:extLst>
              </a:tr>
            </a:tbl>
          </a:graphicData>
        </a:graphic>
      </p:graphicFrame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BAFAA8D8-9717-4820-9FF3-0D5C1948F272}"/>
              </a:ext>
            </a:extLst>
          </p:cNvPr>
          <p:cNvSpPr txBox="1"/>
          <p:nvPr/>
        </p:nvSpPr>
        <p:spPr>
          <a:xfrm>
            <a:off x="305094" y="335877"/>
            <a:ext cx="923522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1. NBI international colorectal endoscopic (NICE) classification*</a:t>
            </a:r>
            <a:r>
              <a:rPr kumimoji="1" lang="en-US" altLang="ja-JP" sz="20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AA19F417-A04A-4798-80A0-B53BE36EDDCE}"/>
              </a:ext>
            </a:extLst>
          </p:cNvPr>
          <p:cNvSpPr txBox="1"/>
          <p:nvPr/>
        </p:nvSpPr>
        <p:spPr>
          <a:xfrm>
            <a:off x="305094" y="9870301"/>
            <a:ext cx="11848804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1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Can be applied using colonoscopes both with or without optical (zoom) magnification.</a:t>
            </a:r>
          </a:p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2. </a:t>
            </a:r>
            <a:r>
              <a:rPr kumimoji="1" lang="en-US" altLang="ja-JP" sz="160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Calibri" pitchFamily="1" charset="0"/>
                <a:cs typeface="Times New Roman" panose="02020603050405020304" pitchFamily="18" charset="0"/>
                <a:sym typeface="Calibri" pitchFamily="1" charset="0"/>
              </a:rPr>
              <a:t>These structures (regular or irregular) may represent the pits and the epithelium of the crypt opening </a:t>
            </a:r>
          </a:p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3. </a:t>
            </a:r>
            <a:r>
              <a:rPr kumimoji="1" lang="en-US" altLang="ja-JP" sz="160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Calibri" pitchFamily="1" charset="0"/>
                <a:cs typeface="Times New Roman" panose="02020603050405020304" pitchFamily="18" charset="0"/>
                <a:sym typeface="Calibri" pitchFamily="1" charset="0"/>
              </a:rPr>
              <a:t>In the WHO </a:t>
            </a:r>
            <a:r>
              <a:rPr kumimoji="1" lang="en-US" altLang="ja-JP" sz="160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Calibri" pitchFamily="1" charset="0"/>
                <a:cs typeface="Times New Roman" panose="02020603050405020304" pitchFamily="18" charset="0"/>
                <a:sym typeface="Calibri" pitchFamily="1" charset="0"/>
              </a:rPr>
              <a:t>cllassification</a:t>
            </a:r>
            <a:r>
              <a:rPr kumimoji="1" lang="en-US" altLang="ja-JP" sz="160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Calibri" pitchFamily="1" charset="0"/>
                <a:cs typeface="Times New Roman" panose="02020603050405020304" pitchFamily="18" charset="0"/>
                <a:sym typeface="Calibri" pitchFamily="1" charset="0"/>
              </a:rPr>
              <a:t> (REF), sessile serrated polyp and sessile serrated adenoma are synonymous.</a:t>
            </a:r>
          </a:p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4. </a:t>
            </a:r>
            <a:r>
              <a:rPr kumimoji="1" lang="en-US" altLang="ja-JP" sz="160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Calibri" pitchFamily="1" charset="0"/>
                <a:cs typeface="Times New Roman" panose="02020603050405020304" pitchFamily="18" charset="0"/>
              </a:rPr>
              <a:t>Type 2 consists of Vienna classification types 3, 4, and superficial 5 (all adenomas with either low or high grade dysplasia, or with </a:t>
            </a:r>
          </a:p>
          <a:p>
            <a:r>
              <a:rPr kumimoji="1" lang="en-US" altLang="ja-JP" sz="160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Calibri" pitchFamily="1" charset="0"/>
                <a:cs typeface="Times New Roman" panose="02020603050405020304" pitchFamily="18" charset="0"/>
              </a:rPr>
              <a:t>      superficial submucosal carcinoma). The presence of high grade dysplasia or superficial submucosal carcinoma may be suggested </a:t>
            </a:r>
          </a:p>
          <a:p>
            <a:r>
              <a:rPr lang="en-US" altLang="ja-JP" sz="1600" dirty="0">
                <a:latin typeface="Times New Roman" panose="02020603050405020304" pitchFamily="18" charset="0"/>
                <a:ea typeface="Calibri" pitchFamily="1" charset="0"/>
                <a:cs typeface="Times New Roman" panose="02020603050405020304" pitchFamily="18" charset="0"/>
              </a:rPr>
              <a:t>      </a:t>
            </a:r>
            <a:r>
              <a:rPr kumimoji="1" lang="en-US" altLang="ja-JP" sz="160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Calibri" pitchFamily="1" charset="0"/>
                <a:cs typeface="Times New Roman" panose="02020603050405020304" pitchFamily="18" charset="0"/>
              </a:rPr>
              <a:t>by an irregular vessel or surface pattern, and is often associated with atypical morphology (e.g., depressed area). 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3" name="図 12">
            <a:extLst>
              <a:ext uri="{FF2B5EF4-FFF2-40B4-BE49-F238E27FC236}">
                <a16:creationId xmlns:a16="http://schemas.microsoft.com/office/drawing/2014/main" id="{8AA8A3C9-1D03-4751-9152-243FF0FBE061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2345294" y="7320057"/>
            <a:ext cx="2577410" cy="2247741"/>
          </a:xfrm>
          <a:prstGeom prst="rect">
            <a:avLst/>
          </a:prstGeom>
        </p:spPr>
      </p:pic>
      <p:pic>
        <p:nvPicPr>
          <p:cNvPr id="14" name="図 13">
            <a:extLst>
              <a:ext uri="{FF2B5EF4-FFF2-40B4-BE49-F238E27FC236}">
                <a16:creationId xmlns:a16="http://schemas.microsoft.com/office/drawing/2014/main" id="{4E2E0D9E-F159-4659-81AC-39CAB3466166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2345292" y="5072315"/>
            <a:ext cx="2577412" cy="2247742"/>
          </a:xfrm>
          <a:prstGeom prst="rect">
            <a:avLst/>
          </a:prstGeom>
        </p:spPr>
      </p:pic>
      <p:pic>
        <p:nvPicPr>
          <p:cNvPr id="15" name="図 14">
            <a:extLst>
              <a:ext uri="{FF2B5EF4-FFF2-40B4-BE49-F238E27FC236}">
                <a16:creationId xmlns:a16="http://schemas.microsoft.com/office/drawing/2014/main" id="{DC5ACD79-AB97-485B-A293-0A09AC86EF5F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5215415" y="5070979"/>
            <a:ext cx="2577410" cy="2249078"/>
          </a:xfrm>
          <a:prstGeom prst="rect">
            <a:avLst/>
          </a:prstGeom>
        </p:spPr>
      </p:pic>
      <p:pic>
        <p:nvPicPr>
          <p:cNvPr id="16" name="図 15">
            <a:extLst>
              <a:ext uri="{FF2B5EF4-FFF2-40B4-BE49-F238E27FC236}">
                <a16:creationId xmlns:a16="http://schemas.microsoft.com/office/drawing/2014/main" id="{238DE128-ED7B-4161-BF79-DC5477A1CC0A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5215415" y="7320057"/>
            <a:ext cx="2586556" cy="2247741"/>
          </a:xfrm>
          <a:prstGeom prst="rect">
            <a:avLst/>
          </a:prstGeom>
        </p:spPr>
      </p:pic>
      <p:pic>
        <p:nvPicPr>
          <p:cNvPr id="18" name="図 17">
            <a:extLst>
              <a:ext uri="{FF2B5EF4-FFF2-40B4-BE49-F238E27FC236}">
                <a16:creationId xmlns:a16="http://schemas.microsoft.com/office/drawing/2014/main" id="{C3CB36B5-8297-4766-80AF-53503671A3E3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731"/>
          <a:stretch/>
        </p:blipFill>
        <p:spPr>
          <a:xfrm>
            <a:off x="8149314" y="7320057"/>
            <a:ext cx="2727418" cy="2247741"/>
          </a:xfrm>
          <a:prstGeom prst="rect">
            <a:avLst/>
          </a:prstGeom>
        </p:spPr>
      </p:pic>
      <p:pic>
        <p:nvPicPr>
          <p:cNvPr id="12" name="図 11">
            <a:extLst>
              <a:ext uri="{FF2B5EF4-FFF2-40B4-BE49-F238E27FC236}">
                <a16:creationId xmlns:a16="http://schemas.microsoft.com/office/drawing/2014/main" id="{6C5C0E76-805D-4EDC-99F1-C7CE4D4468E8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t="5482" r="-355"/>
          <a:stretch/>
        </p:blipFill>
        <p:spPr>
          <a:xfrm>
            <a:off x="8140167" y="5070979"/>
            <a:ext cx="2736564" cy="224971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4823064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4">
            <a:extLst>
              <a:ext uri="{FF2B5EF4-FFF2-40B4-BE49-F238E27FC236}">
                <a16:creationId xmlns:a16="http://schemas.microsoft.com/office/drawing/2014/main" id="{1E2CEBDB-68C5-4734-A965-8BB0A2C678C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36057" y="11089597"/>
            <a:ext cx="2528548" cy="252854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" name="図 2">
            <a:extLst>
              <a:ext uri="{FF2B5EF4-FFF2-40B4-BE49-F238E27FC236}">
                <a16:creationId xmlns:a16="http://schemas.microsoft.com/office/drawing/2014/main" id="{B38BF391-A278-4A0A-BBA4-CEC4C1C5569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02626" y="10969356"/>
            <a:ext cx="2528548" cy="252854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Rectangle 5">
            <a:extLst>
              <a:ext uri="{FF2B5EF4-FFF2-40B4-BE49-F238E27FC236}">
                <a16:creationId xmlns:a16="http://schemas.microsoft.com/office/drawing/2014/main" id="{8820BBB8-236B-4901-A681-88518C34BA9A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61112" y="13707291"/>
            <a:ext cx="8605882" cy="6463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>
            <a:lvl1pPr indent="120015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tabLst/>
            </a:pPr>
            <a:r>
              <a:rPr kumimoji="0" lang="en-US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(a)Magnified NBI image (415x415)      (b)Magnified Laser-BLI image (415x415)</a:t>
            </a:r>
            <a:endParaRPr kumimoji="0" lang="en-US" altLang="ja-JP" sz="1400" dirty="0"/>
          </a:p>
          <a:p>
            <a:pPr marL="0" marR="0" lvl="0" indent="120015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C334847D-B44E-45AF-9617-04B06364612E}"/>
              </a:ext>
            </a:extLst>
          </p:cNvPr>
          <p:cNvSpPr txBox="1"/>
          <p:nvPr/>
        </p:nvSpPr>
        <p:spPr>
          <a:xfrm>
            <a:off x="1767537" y="10510877"/>
            <a:ext cx="715268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tabLst/>
            </a:pPr>
            <a:r>
              <a:rPr kumimoji="0" lang="en-US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upplemental Figure 3: Cropped images of colorectal polyp  </a:t>
            </a:r>
            <a:endParaRPr kumimoji="0" lang="en-US" altLang="ja-JP" sz="1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graphicFrame>
        <p:nvGraphicFramePr>
          <p:cNvPr id="6" name="表 2">
            <a:extLst>
              <a:ext uri="{FF2B5EF4-FFF2-40B4-BE49-F238E27FC236}">
                <a16:creationId xmlns:a16="http://schemas.microsoft.com/office/drawing/2014/main" id="{602DDEBB-3C2C-40CC-B786-2732E1A5ED8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74782208"/>
              </p:ext>
            </p:extLst>
          </p:nvPr>
        </p:nvGraphicFramePr>
        <p:xfrm>
          <a:off x="171597" y="1694956"/>
          <a:ext cx="11848805" cy="5748361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619777">
                  <a:extLst>
                    <a:ext uri="{9D8B030D-6E8A-4147-A177-3AD203B41FA5}">
                      <a16:colId xmlns:a16="http://schemas.microsoft.com/office/drawing/2014/main" val="444079962"/>
                    </a:ext>
                  </a:extLst>
                </a:gridCol>
                <a:gridCol w="2456895">
                  <a:extLst>
                    <a:ext uri="{9D8B030D-6E8A-4147-A177-3AD203B41FA5}">
                      <a16:colId xmlns:a16="http://schemas.microsoft.com/office/drawing/2014/main" val="835315211"/>
                    </a:ext>
                  </a:extLst>
                </a:gridCol>
                <a:gridCol w="2589917">
                  <a:extLst>
                    <a:ext uri="{9D8B030D-6E8A-4147-A177-3AD203B41FA5}">
                      <a16:colId xmlns:a16="http://schemas.microsoft.com/office/drawing/2014/main" val="3566343448"/>
                    </a:ext>
                  </a:extLst>
                </a:gridCol>
                <a:gridCol w="2528614">
                  <a:extLst>
                    <a:ext uri="{9D8B030D-6E8A-4147-A177-3AD203B41FA5}">
                      <a16:colId xmlns:a16="http://schemas.microsoft.com/office/drawing/2014/main" val="2023200414"/>
                    </a:ext>
                  </a:extLst>
                </a:gridCol>
                <a:gridCol w="2653602">
                  <a:extLst>
                    <a:ext uri="{9D8B030D-6E8A-4147-A177-3AD203B41FA5}">
                      <a16:colId xmlns:a16="http://schemas.microsoft.com/office/drawing/2014/main" val="2605092248"/>
                    </a:ext>
                  </a:extLst>
                </a:gridCol>
              </a:tblGrid>
              <a:tr h="399312">
                <a:tc>
                  <a:txBody>
                    <a:bodyPr/>
                    <a:lstStyle/>
                    <a:p>
                      <a:pPr algn="ctr"/>
                      <a:endParaRPr kumimoji="1" lang="ja-JP" altLang="en-US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ype 1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ype 2A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ype 2B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ype</a:t>
                      </a:r>
                      <a:r>
                        <a:rPr kumimoji="1" lang="ja-JP" altLang="en-US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68776682"/>
                  </a:ext>
                </a:extLst>
              </a:tr>
              <a:tr h="996212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essel pattern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visible*</a:t>
                      </a:r>
                      <a:r>
                        <a:rPr kumimoji="1" lang="en-US" altLang="ja-JP" sz="1600" baseline="30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kumimoji="1" lang="ja-JP" altLang="en-US" sz="1600" baseline="30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gular caliber</a:t>
                      </a:r>
                    </a:p>
                    <a:p>
                      <a:pPr algn="ctr"/>
                      <a:r>
                        <a:rPr kumimoji="1" lang="en-US" altLang="ja-JP" sz="16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gular distribution</a:t>
                      </a:r>
                    </a:p>
                    <a:p>
                      <a:pPr algn="ctr"/>
                      <a:r>
                        <a:rPr kumimoji="1" lang="en-US" altLang="ja-JP" sz="16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meshed/spiral pattern)</a:t>
                      </a:r>
                      <a:endParaRPr kumimoji="1" lang="ja-JP" altLang="en-US" sz="16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ariable caliver</a:t>
                      </a:r>
                    </a:p>
                    <a:p>
                      <a:pPr algn="ctr"/>
                      <a:r>
                        <a:rPr kumimoji="1" lang="en-US" altLang="ja-JP" sz="16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rregular distribution</a:t>
                      </a:r>
                      <a:endParaRPr kumimoji="1" lang="ja-JP" altLang="en-US" sz="16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ose vessel areas</a:t>
                      </a:r>
                    </a:p>
                    <a:p>
                      <a:pPr algn="ctr"/>
                      <a:r>
                        <a:rPr kumimoji="1" lang="en-US" altLang="ja-JP" sz="16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terruption of thick vessels</a:t>
                      </a:r>
                      <a:endParaRPr kumimoji="1" lang="ja-JP" altLang="en-US" sz="16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45403526"/>
                  </a:ext>
                </a:extLst>
              </a:tr>
              <a:tr h="105410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rface pattern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gular dark or white spots</a:t>
                      </a:r>
                    </a:p>
                    <a:p>
                      <a:pPr algn="ctr"/>
                      <a:r>
                        <a:rPr kumimoji="1" lang="en-US" altLang="ja-JP" sz="16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imilar to surrounding normal mucosa</a:t>
                      </a:r>
                      <a:endParaRPr kumimoji="1" lang="ja-JP" altLang="en-US" sz="16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gular</a:t>
                      </a:r>
                    </a:p>
                    <a:p>
                      <a:pPr algn="ctr"/>
                      <a:r>
                        <a:rPr kumimoji="1" lang="en-US" altLang="ja-JP" sz="16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tubular/branched/papillary)</a:t>
                      </a:r>
                      <a:endParaRPr kumimoji="1" lang="ja-JP" altLang="en-US" sz="16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rregular or obscure</a:t>
                      </a:r>
                      <a:endParaRPr kumimoji="1" lang="ja-JP" altLang="en-US" sz="16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morphous areas</a:t>
                      </a:r>
                      <a:endParaRPr kumimoji="1" lang="ja-JP" altLang="en-US" sz="16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45754433"/>
                  </a:ext>
                </a:extLst>
              </a:tr>
              <a:tr h="100330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st likely histology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yperplastic polyp</a:t>
                      </a:r>
                    </a:p>
                    <a:p>
                      <a:pPr algn="ctr"/>
                      <a:r>
                        <a:rPr kumimoji="1" lang="en-US" altLang="ja-JP" sz="16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ssile serrated lesion</a:t>
                      </a:r>
                      <a:endParaRPr kumimoji="1" lang="ja-JP" altLang="en-US" sz="16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w grade intramucosal neoplasia</a:t>
                      </a:r>
                      <a:endParaRPr kumimoji="1" lang="ja-JP" altLang="en-US" sz="16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gh grade intramucosal neoplasia/ Shallow submucosal invasive cancer</a:t>
                      </a:r>
                      <a:endParaRPr kumimoji="1" lang="ja-JP" altLang="en-US" sz="16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ep submucosal invasive cancer</a:t>
                      </a:r>
                      <a:endParaRPr kumimoji="1" lang="ja-JP" altLang="en-US" sz="16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42012251"/>
                  </a:ext>
                </a:extLst>
              </a:tr>
              <a:tr h="2237549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ndoscopic image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16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16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16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16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16240594"/>
                  </a:ext>
                </a:extLst>
              </a:tr>
            </a:tbl>
          </a:graphicData>
        </a:graphic>
      </p:graphicFrame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8970D608-CFD4-4438-B7FE-61C81D5C064F}"/>
              </a:ext>
            </a:extLst>
          </p:cNvPr>
          <p:cNvSpPr txBox="1"/>
          <p:nvPr/>
        </p:nvSpPr>
        <p:spPr>
          <a:xfrm>
            <a:off x="42520" y="7474696"/>
            <a:ext cx="12149480" cy="8617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1.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f visible, the caliver in the lesion is similar to surrounding normal mucosa.</a:t>
            </a:r>
          </a:p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2. Micro-vessels are often distributed in a punctate pattern and well-ordered reticular or spiral vessels may not be observed in depressed lesions.</a:t>
            </a:r>
          </a:p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3. Deep submucosal invasive cancer my be included. 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28A75F90-C335-4898-9E82-34C8C9FCF2EC}"/>
              </a:ext>
            </a:extLst>
          </p:cNvPr>
          <p:cNvSpPr txBox="1"/>
          <p:nvPr/>
        </p:nvSpPr>
        <p:spPr>
          <a:xfrm>
            <a:off x="154437" y="1081597"/>
            <a:ext cx="724589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2. Japan NBI expert team (JNET) classification</a:t>
            </a:r>
          </a:p>
        </p:txBody>
      </p:sp>
      <p:pic>
        <p:nvPicPr>
          <p:cNvPr id="9" name="図 8">
            <a:extLst>
              <a:ext uri="{FF2B5EF4-FFF2-40B4-BE49-F238E27FC236}">
                <a16:creationId xmlns:a16="http://schemas.microsoft.com/office/drawing/2014/main" id="{62514452-F2E2-463D-A2CB-0C7D5BE09535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3854" t="58819" r="66835" b="3449"/>
          <a:stretch/>
        </p:blipFill>
        <p:spPr>
          <a:xfrm>
            <a:off x="1805252" y="5233688"/>
            <a:ext cx="2436082" cy="220962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" name="図 9">
            <a:extLst>
              <a:ext uri="{FF2B5EF4-FFF2-40B4-BE49-F238E27FC236}">
                <a16:creationId xmlns:a16="http://schemas.microsoft.com/office/drawing/2014/main" id="{6A718B5B-23ED-4470-B16F-CFA0D88B3A97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35570" t="58819" r="45204" b="3449"/>
          <a:stretch/>
        </p:blipFill>
        <p:spPr>
          <a:xfrm>
            <a:off x="4332774" y="5233688"/>
            <a:ext cx="2425355" cy="220962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" name="図 10">
            <a:extLst>
              <a:ext uri="{FF2B5EF4-FFF2-40B4-BE49-F238E27FC236}">
                <a16:creationId xmlns:a16="http://schemas.microsoft.com/office/drawing/2014/main" id="{0ED80091-7165-4109-92E8-817F04C6BD59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56966" t="58819" r="23515" b="3449"/>
          <a:stretch/>
        </p:blipFill>
        <p:spPr>
          <a:xfrm>
            <a:off x="6872428" y="5233688"/>
            <a:ext cx="2462411" cy="220962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2" name="図 11">
            <a:extLst>
              <a:ext uri="{FF2B5EF4-FFF2-40B4-BE49-F238E27FC236}">
                <a16:creationId xmlns:a16="http://schemas.microsoft.com/office/drawing/2014/main" id="{D6FD4EDE-F2A1-40BE-AFB5-CB4CB4D84175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78307" t="58819" r="2382" b="3449"/>
          <a:stretch/>
        </p:blipFill>
        <p:spPr>
          <a:xfrm>
            <a:off x="9464379" y="5226068"/>
            <a:ext cx="2436082" cy="2209629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345299948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E0C7EF99-6F90-4115-81E7-695C42B281A0}"/>
              </a:ext>
            </a:extLst>
          </p:cNvPr>
          <p:cNvSpPr txBox="1"/>
          <p:nvPr/>
        </p:nvSpPr>
        <p:spPr>
          <a:xfrm>
            <a:off x="698512" y="1428670"/>
            <a:ext cx="10580332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Table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lationship between NICE classification and pathological findings, diagnostic performance of NBI, Laser-BLI </a:t>
            </a:r>
          </a:p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LED-BLI </a:t>
            </a:r>
            <a:r>
              <a:rPr lang="en-US" altLang="ja-JP" sz="18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results of each four evaluator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" name="表 1">
            <a:extLst>
              <a:ext uri="{FF2B5EF4-FFF2-40B4-BE49-F238E27FC236}">
                <a16:creationId xmlns:a16="http://schemas.microsoft.com/office/drawing/2014/main" id="{8B16AFDE-4102-4113-AF40-E3603D92F40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93891110"/>
              </p:ext>
            </p:extLst>
          </p:nvPr>
        </p:nvGraphicFramePr>
        <p:xfrm>
          <a:off x="172630" y="2414829"/>
          <a:ext cx="11846740" cy="10489521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476725">
                  <a:extLst>
                    <a:ext uri="{9D8B030D-6E8A-4147-A177-3AD203B41FA5}">
                      <a16:colId xmlns:a16="http://schemas.microsoft.com/office/drawing/2014/main" val="4163824474"/>
                    </a:ext>
                  </a:extLst>
                </a:gridCol>
                <a:gridCol w="476725">
                  <a:extLst>
                    <a:ext uri="{9D8B030D-6E8A-4147-A177-3AD203B41FA5}">
                      <a16:colId xmlns:a16="http://schemas.microsoft.com/office/drawing/2014/main" val="570401488"/>
                    </a:ext>
                  </a:extLst>
                </a:gridCol>
                <a:gridCol w="889316">
                  <a:extLst>
                    <a:ext uri="{9D8B030D-6E8A-4147-A177-3AD203B41FA5}">
                      <a16:colId xmlns:a16="http://schemas.microsoft.com/office/drawing/2014/main" val="590934235"/>
                    </a:ext>
                  </a:extLst>
                </a:gridCol>
                <a:gridCol w="1035901">
                  <a:extLst>
                    <a:ext uri="{9D8B030D-6E8A-4147-A177-3AD203B41FA5}">
                      <a16:colId xmlns:a16="http://schemas.microsoft.com/office/drawing/2014/main" val="1909442611"/>
                    </a:ext>
                  </a:extLst>
                </a:gridCol>
                <a:gridCol w="889000">
                  <a:extLst>
                    <a:ext uri="{9D8B030D-6E8A-4147-A177-3AD203B41FA5}">
                      <a16:colId xmlns:a16="http://schemas.microsoft.com/office/drawing/2014/main" val="3050339693"/>
                    </a:ext>
                  </a:extLst>
                </a:gridCol>
                <a:gridCol w="1185333">
                  <a:extLst>
                    <a:ext uri="{9D8B030D-6E8A-4147-A177-3AD203B41FA5}">
                      <a16:colId xmlns:a16="http://schemas.microsoft.com/office/drawing/2014/main" val="3343864707"/>
                    </a:ext>
                  </a:extLst>
                </a:gridCol>
                <a:gridCol w="719667">
                  <a:extLst>
                    <a:ext uri="{9D8B030D-6E8A-4147-A177-3AD203B41FA5}">
                      <a16:colId xmlns:a16="http://schemas.microsoft.com/office/drawing/2014/main" val="708647273"/>
                    </a:ext>
                  </a:extLst>
                </a:gridCol>
                <a:gridCol w="101600">
                  <a:extLst>
                    <a:ext uri="{9D8B030D-6E8A-4147-A177-3AD203B41FA5}">
                      <a16:colId xmlns:a16="http://schemas.microsoft.com/office/drawing/2014/main" val="3190960854"/>
                    </a:ext>
                  </a:extLst>
                </a:gridCol>
                <a:gridCol w="1202267">
                  <a:extLst>
                    <a:ext uri="{9D8B030D-6E8A-4147-A177-3AD203B41FA5}">
                      <a16:colId xmlns:a16="http://schemas.microsoft.com/office/drawing/2014/main" val="1036683323"/>
                    </a:ext>
                  </a:extLst>
                </a:gridCol>
                <a:gridCol w="1236133">
                  <a:extLst>
                    <a:ext uri="{9D8B030D-6E8A-4147-A177-3AD203B41FA5}">
                      <a16:colId xmlns:a16="http://schemas.microsoft.com/office/drawing/2014/main" val="1177727745"/>
                    </a:ext>
                  </a:extLst>
                </a:gridCol>
                <a:gridCol w="1236133">
                  <a:extLst>
                    <a:ext uri="{9D8B030D-6E8A-4147-A177-3AD203B41FA5}">
                      <a16:colId xmlns:a16="http://schemas.microsoft.com/office/drawing/2014/main" val="261929072"/>
                    </a:ext>
                  </a:extLst>
                </a:gridCol>
                <a:gridCol w="1196543">
                  <a:extLst>
                    <a:ext uri="{9D8B030D-6E8A-4147-A177-3AD203B41FA5}">
                      <a16:colId xmlns:a16="http://schemas.microsoft.com/office/drawing/2014/main" val="1639862295"/>
                    </a:ext>
                  </a:extLst>
                </a:gridCol>
                <a:gridCol w="1201397">
                  <a:extLst>
                    <a:ext uri="{9D8B030D-6E8A-4147-A177-3AD203B41FA5}">
                      <a16:colId xmlns:a16="http://schemas.microsoft.com/office/drawing/2014/main" val="51232554"/>
                    </a:ext>
                  </a:extLst>
                </a:gridCol>
              </a:tblGrid>
              <a:tr h="140600">
                <a:tc>
                  <a:txBody>
                    <a:bodyPr/>
                    <a:lstStyle/>
                    <a:p>
                      <a:pPr algn="l" fontAlgn="t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gridSpan="3"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pathological findings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gridSpan="5"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Diagnostic performanc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17963265"/>
                  </a:ext>
                </a:extLst>
              </a:tr>
              <a:tr h="275575">
                <a:tc>
                  <a:txBody>
                    <a:bodyPr/>
                    <a:lstStyle/>
                    <a:p>
                      <a:pPr algn="l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NICE classification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N (%)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>
                          <a:effectLst/>
                          <a:latin typeface="+mn-lt"/>
                        </a:rPr>
                        <a:t>HP/SSP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21917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LGD+</a:t>
                      </a:r>
                      <a:r>
                        <a:rPr lang="en-US" altLang="ja-JP" sz="1200" u="none" strike="noStrike" dirty="0">
                          <a:effectLst/>
                          <a:latin typeface="+mn-lt"/>
                        </a:rPr>
                        <a:t>HGD+s-SM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>
                          <a:effectLst/>
                          <a:latin typeface="+mn-lt"/>
                        </a:rPr>
                        <a:t>d-SM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u="none" strike="noStrike" dirty="0">
                          <a:effectLst/>
                          <a:latin typeface="+mn-lt"/>
                        </a:rPr>
                        <a:t>Sensitivity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Specificity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PPV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>
                          <a:effectLst/>
                          <a:latin typeface="+mn-lt"/>
                        </a:rPr>
                        <a:t>NPV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>
                          <a:effectLst/>
                          <a:latin typeface="+mn-lt"/>
                        </a:rPr>
                        <a:t>Accuracy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53498123"/>
                  </a:ext>
                </a:extLst>
              </a:tr>
              <a:tr h="202464">
                <a:tc rowSpan="12">
                  <a:txBody>
                    <a:bodyPr/>
                    <a:lstStyle/>
                    <a:p>
                      <a:pPr marL="0" marR="0" lvl="0" indent="0" algn="ctr" defTabSz="121917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</a:rPr>
                        <a:t>Evaluator 1</a:t>
                      </a:r>
                    </a:p>
                  </a:txBody>
                  <a:tcPr marL="7620" marR="7620" marT="7620" marB="0" vert="vert27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NBI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Type 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36 (18.6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33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9.2 (79.2-99.2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8.1 (95.9-100.2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1.7 (82.6-100.7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7.5 (95.0-99.9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6.4 (93.8-99.0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35806207"/>
                  </a:ext>
                </a:extLst>
              </a:tr>
              <a:tr h="202464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l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Type 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56 (80.4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4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52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7.4 (95.0-99.9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9.5 (75.3-96.4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333333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7.4 (95.0-99.9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9.5 (79.7-99.2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5.9 (93.1-98.7</a:t>
                      </a:r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）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3911770"/>
                  </a:ext>
                </a:extLst>
              </a:tr>
              <a:tr h="275575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l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Type 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2 (1.0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00 (100.0-100.0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9.5 (96.5-100.5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50 (-19.3-119.3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00 (100.0-100.0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9.5 (98.5-100.5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9186977"/>
                  </a:ext>
                </a:extLst>
              </a:tr>
              <a:tr h="202464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l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Total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94 (100)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37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56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95857064"/>
                  </a:ext>
                </a:extLst>
              </a:tr>
              <a:tr h="202464">
                <a:tc vMerge="1">
                  <a:txBody>
                    <a:bodyPr/>
                    <a:lstStyle/>
                    <a:p>
                      <a:pPr algn="ctr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Laser-</a:t>
                      </a:r>
                    </a:p>
                    <a:p>
                      <a:pPr algn="ctr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BLI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Type 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49 (22.4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46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200" u="none" strike="noStrike" dirty="0">
                          <a:effectLst/>
                          <a:latin typeface="+mn-lt"/>
                        </a:rPr>
                        <a:t>0</a:t>
                      </a:r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71.9 (60.9-82.9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8.1 (95.9-100.2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3.9 (87.2-100.6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9.4 (84.8-94.0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0.4 (86.5-94.3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22950462"/>
                  </a:ext>
                </a:extLst>
              </a:tr>
              <a:tr h="202464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l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Type 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68 (76.7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8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5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200" u="none" strike="noStrike" dirty="0">
                          <a:effectLst/>
                          <a:latin typeface="+mn-lt"/>
                        </a:rPr>
                        <a:t>0</a:t>
                      </a:r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6.8 (94.0-99.6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76.6 (66.2-86.9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333333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9.3 (84.6-94.0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0.2 (72.0-98.4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9.5 (85.4-93.6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45844150"/>
                  </a:ext>
                </a:extLst>
              </a:tr>
              <a:tr h="275575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l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Type 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2 (0.9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2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200" u="none" strike="noStrike" dirty="0">
                          <a:effectLst/>
                          <a:latin typeface="+mn-lt"/>
                        </a:rPr>
                        <a:t>0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N/A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00 (100.0-100.0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 (0.0-0.0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00 (100.0-100.0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9.1 (97.8-100.3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35068790"/>
                  </a:ext>
                </a:extLst>
              </a:tr>
              <a:tr h="202464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l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Total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219 (100)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64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55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98241543"/>
                  </a:ext>
                </a:extLst>
              </a:tr>
              <a:tr h="202464">
                <a:tc vMerge="1">
                  <a:txBody>
                    <a:bodyPr/>
                    <a:lstStyle/>
                    <a:p>
                      <a:pPr algn="ctr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LED-</a:t>
                      </a:r>
                    </a:p>
                    <a:p>
                      <a:pPr algn="ctr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BLI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Type 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41 (21.4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36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5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66.7 (54.1-79.2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6.4 (93.3-99.5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7.8 (77.8-97.8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8.1 (82.9-93.2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8.0 (83.4-92.6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87238822"/>
                  </a:ext>
                </a:extLst>
              </a:tr>
              <a:tr h="202464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l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Type 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51 (78.6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8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33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6.4 (93.3-99.5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66.7 (54.1-79.2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8.1 (82.9-93.2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7.8 (77.8-97.8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8.0 (83.4-92.6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80843453"/>
                  </a:ext>
                </a:extLst>
              </a:tr>
              <a:tr h="275575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l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Type 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 (0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N/A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00 (100.0-100.0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N/A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00 (100.0-100.0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00 (100.0-100.0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97843632"/>
                  </a:ext>
                </a:extLst>
              </a:tr>
              <a:tr h="202464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l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Total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92 (100)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54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38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11933469"/>
                  </a:ext>
                </a:extLst>
              </a:tr>
              <a:tr h="202464">
                <a:tc rowSpan="12">
                  <a:txBody>
                    <a:bodyPr/>
                    <a:lstStyle/>
                    <a:p>
                      <a:pPr marL="0" marR="0" lvl="0" indent="0" algn="ctr" defTabSz="121917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</a:rPr>
                        <a:t>Evaluator 2</a:t>
                      </a:r>
                    </a:p>
                  </a:txBody>
                  <a:tcPr marL="7620" marR="7620" marT="7620" marB="0" vert="vert27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NBI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Type 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50 (26.7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31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9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6.1 (74.8-97.4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7.4 (82.1-92.7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62.0 (48.5-75.5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6.4 (93.2-99.5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7.2 (82.4-92.0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09122204"/>
                  </a:ext>
                </a:extLst>
              </a:tr>
              <a:tr h="202464">
                <a:tc vMerge="1">
                  <a:txBody>
                    <a:bodyPr/>
                    <a:lstStyle/>
                    <a:p>
                      <a:pPr algn="ctr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l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Type 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35 (72.2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5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3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6.7 (81.2-92.1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6.5 (75.5-97.5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333333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6.3 (93.1-99.5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61.5 (48.3-74.8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6.6 (81.8-91.5</a:t>
                      </a:r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）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67653764"/>
                  </a:ext>
                </a:extLst>
              </a:tr>
              <a:tr h="202464">
                <a:tc vMerge="1">
                  <a:txBody>
                    <a:bodyPr/>
                    <a:lstStyle/>
                    <a:p>
                      <a:pPr algn="ctr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l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Type 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2 (1.1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00 (100.0-100.0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9.5 (98.4-100.5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50 (-19.3-119.3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00 (100.0-100.0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9.5 (98.4-100.5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71280211"/>
                  </a:ext>
                </a:extLst>
              </a:tr>
              <a:tr h="202464">
                <a:tc vMerge="1">
                  <a:txBody>
                    <a:bodyPr/>
                    <a:lstStyle/>
                    <a:p>
                      <a:pPr algn="ctr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l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Total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87 (100)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36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50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70746908"/>
                  </a:ext>
                </a:extLst>
              </a:tr>
              <a:tr h="202464">
                <a:tc vMerge="1">
                  <a:txBody>
                    <a:bodyPr/>
                    <a:lstStyle/>
                    <a:p>
                      <a:pPr algn="ctr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Laser-</a:t>
                      </a:r>
                    </a:p>
                    <a:p>
                      <a:pPr algn="ctr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BLI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Type 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64 (29.5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55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5.9 (77.4-94.5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4.1 (90.4-97.8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5.9 (77.4-94.5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4.1 (90.4-97.8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1.7 (88.0-95.4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06348024"/>
                  </a:ext>
                </a:extLst>
              </a:tr>
              <a:tr h="202464">
                <a:tc vMerge="1">
                  <a:txBody>
                    <a:bodyPr/>
                    <a:lstStyle/>
                    <a:p>
                      <a:pPr algn="ctr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l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Type 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53 (70.5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44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4.1 (90.4-97.8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5.9 (77.4-94.5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4.1 (90.4-97.8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5.9 (77.4-94.5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1.7 (88.0-95.4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34234211"/>
                  </a:ext>
                </a:extLst>
              </a:tr>
              <a:tr h="202464">
                <a:tc vMerge="1">
                  <a:txBody>
                    <a:bodyPr/>
                    <a:lstStyle/>
                    <a:p>
                      <a:pPr algn="ctr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l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Type 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 (0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N/A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00 (100.0-100.0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N/A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00 (100.0-100.0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00 (100.0-100.0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0614175"/>
                  </a:ext>
                </a:extLst>
              </a:tr>
              <a:tr h="202464">
                <a:tc vMerge="1">
                  <a:txBody>
                    <a:bodyPr/>
                    <a:lstStyle/>
                    <a:p>
                      <a:pPr algn="ctr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l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Total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217 (100)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64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53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27723778"/>
                  </a:ext>
                </a:extLst>
              </a:tr>
              <a:tr h="202464">
                <a:tc vMerge="1">
                  <a:txBody>
                    <a:bodyPr/>
                    <a:lstStyle/>
                    <a:p>
                      <a:pPr algn="ctr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LED-</a:t>
                      </a:r>
                    </a:p>
                    <a:p>
                      <a:pPr algn="ctr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BLI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Type 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65 (34.4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47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8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0.4 (82.4-98.4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6.9 (81.2-92.5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72.3 (61.4-83.2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6.0 (92.5-99.4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7.8 (83.2-92.5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41044983"/>
                  </a:ext>
                </a:extLst>
              </a:tr>
              <a:tr h="202464">
                <a:tc vMerge="1">
                  <a:txBody>
                    <a:bodyPr/>
                    <a:lstStyle/>
                    <a:p>
                      <a:pPr algn="ctr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l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Type 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24 (65.6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5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19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6.9 (81.2-92.5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0.4 (82.4-98.4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6.0 (92.5-99.4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72.3 (61.4-83.2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7.8 (83.2-92.5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2038015"/>
                  </a:ext>
                </a:extLst>
              </a:tr>
              <a:tr h="202464">
                <a:tc vMerge="1">
                  <a:txBody>
                    <a:bodyPr/>
                    <a:lstStyle/>
                    <a:p>
                      <a:pPr algn="ctr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l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Type 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 (0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N/A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00 (100.0-100.0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N/A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00 (100.0-100.0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00 (100.0-100.0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35770518"/>
                  </a:ext>
                </a:extLst>
              </a:tr>
              <a:tr h="202464">
                <a:tc vMerge="1">
                  <a:txBody>
                    <a:bodyPr/>
                    <a:lstStyle/>
                    <a:p>
                      <a:pPr algn="ctr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vMerge="1">
                  <a:txBody>
                    <a:bodyPr/>
                    <a:lstStyle/>
                    <a:p>
                      <a:pPr algn="l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Total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89 (100)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52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37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84979972"/>
                  </a:ext>
                </a:extLst>
              </a:tr>
              <a:tr h="202464">
                <a:tc rowSpan="12">
                  <a:txBody>
                    <a:bodyPr/>
                    <a:lstStyle/>
                    <a:p>
                      <a:pPr marL="0" marR="0" lvl="0" indent="0" algn="ctr" defTabSz="121917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</a:rPr>
                        <a:t>Evaluator 3</a:t>
                      </a:r>
                    </a:p>
                  </a:txBody>
                  <a:tcPr marL="7620" marR="7620" marT="7620" marB="0" vert="vert27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NBI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Type 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44 (22.7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29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5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78.4 (65.1-91.6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0.4 (85.8-95.0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65.9 (51.9-79.9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3.4 (89.5-97.4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8.1 (83.6-92.7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96086677"/>
                  </a:ext>
                </a:extLst>
              </a:tr>
              <a:tr h="202464">
                <a:tc vMerge="1">
                  <a:txBody>
                    <a:bodyPr/>
                    <a:lstStyle/>
                    <a:p>
                      <a:pPr algn="ctr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l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Type 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49 (76.8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41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0.4 (85.8-95.0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78.9 (66.0-91.9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rgbClr val="333333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4.6 (91.0-98.3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66.7 (52.9-80.4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8.1 (83.6-92.7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08905208"/>
                  </a:ext>
                </a:extLst>
              </a:tr>
              <a:tr h="202464">
                <a:tc vMerge="1">
                  <a:txBody>
                    <a:bodyPr/>
                    <a:lstStyle/>
                    <a:p>
                      <a:pPr algn="ctr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l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Type 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 (0.5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00 (16.8-103.9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00 (100.0-100.0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00 (100.0-100.0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00 (100.0-100.0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00 (100.0-100.0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98907234"/>
                  </a:ext>
                </a:extLst>
              </a:tr>
              <a:tr h="202464">
                <a:tc vMerge="1">
                  <a:txBody>
                    <a:bodyPr/>
                    <a:lstStyle/>
                    <a:p>
                      <a:pPr algn="ctr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l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Total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94 (100)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37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56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36021796"/>
                  </a:ext>
                </a:extLst>
              </a:tr>
              <a:tr h="202464">
                <a:tc vMerge="1">
                  <a:txBody>
                    <a:bodyPr/>
                    <a:lstStyle/>
                    <a:p>
                      <a:pPr algn="ctr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Laser-</a:t>
                      </a:r>
                    </a:p>
                    <a:p>
                      <a:pPr algn="ctr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BLI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Type 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61 (27.9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55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6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5.9 (77.4-94.5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6.1 (93.1-99.2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0.2 (72.7-97.6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4.3 (90.7-97.9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3.2 (89.8-96.5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45961727"/>
                  </a:ext>
                </a:extLst>
              </a:tr>
              <a:tr h="202464">
                <a:tc vMerge="1">
                  <a:txBody>
                    <a:bodyPr/>
                    <a:lstStyle/>
                    <a:p>
                      <a:pPr algn="ctr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l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Type 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57 (71.7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48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5.5 (92.2-98.8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5.9 (77.4-94.5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4.3 (90.6-97.9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8.7 (80.8-96.6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2.7 (89.2-96.1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54264313"/>
                  </a:ext>
                </a:extLst>
              </a:tr>
              <a:tr h="202464">
                <a:tc vMerge="1">
                  <a:txBody>
                    <a:bodyPr/>
                    <a:lstStyle/>
                    <a:p>
                      <a:pPr algn="ctr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l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Type 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 (0.5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N/A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9.5 (98.7-100.4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 (0.0-0.0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00 (100.0-100.0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9.5 (98.7-100.4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61380192"/>
                  </a:ext>
                </a:extLst>
              </a:tr>
              <a:tr h="202464">
                <a:tc vMerge="1">
                  <a:txBody>
                    <a:bodyPr/>
                    <a:lstStyle/>
                    <a:p>
                      <a:pPr algn="ctr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l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Total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219 (100)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64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55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53894908"/>
                  </a:ext>
                </a:extLst>
              </a:tr>
              <a:tr h="202464">
                <a:tc vMerge="1">
                  <a:txBody>
                    <a:bodyPr/>
                    <a:lstStyle/>
                    <a:p>
                      <a:pPr algn="ctr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LED-</a:t>
                      </a:r>
                    </a:p>
                    <a:p>
                      <a:pPr algn="ctr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BLI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Type 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63 (32.8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48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5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8.9 (80.5-97.3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9.1 (83.9-94.3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76.2 (65.7-86.7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5.3 (91.7-99.0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9.1 (84.6-93.5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22499423"/>
                  </a:ext>
                </a:extLst>
              </a:tr>
              <a:tr h="202464">
                <a:tc vMerge="1">
                  <a:txBody>
                    <a:bodyPr/>
                    <a:lstStyle/>
                    <a:p>
                      <a:pPr algn="ctr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l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Type 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29 (67.2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6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23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9.1 (83.9-94.3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8.9 (80.5-97.3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5.3 (91.7-99.0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76.2 (65.7-86.7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9.1 (84.6-93.5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32393308"/>
                  </a:ext>
                </a:extLst>
              </a:tr>
              <a:tr h="202464">
                <a:tc vMerge="1">
                  <a:txBody>
                    <a:bodyPr/>
                    <a:lstStyle/>
                    <a:p>
                      <a:pPr algn="ctr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l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Type 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 (0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N/A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00 (100.0-100.0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N/A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00 (100.0-100.0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00 (100.0-100.0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89305076"/>
                  </a:ext>
                </a:extLst>
              </a:tr>
              <a:tr h="202464">
                <a:tc vMerge="1">
                  <a:txBody>
                    <a:bodyPr/>
                    <a:lstStyle/>
                    <a:p>
                      <a:pPr algn="ctr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l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Total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92 (100)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54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38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69395705"/>
                  </a:ext>
                </a:extLst>
              </a:tr>
              <a:tr h="202464">
                <a:tc rowSpan="12"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</a:rPr>
                        <a:t>Evaluator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 4</a:t>
                      </a:r>
                    </a:p>
                  </a:txBody>
                  <a:tcPr marL="7620" marR="7620" marT="7620" marB="0" vert="vert27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NBI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Type 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46 (24.2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32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4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8.9 (78.6-99.2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0.9(86.4-95.4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69.6(56.3-82.9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7.2 (94.5-99.9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0.5 (86.4-94.7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40229653"/>
                  </a:ext>
                </a:extLst>
              </a:tr>
              <a:tr h="202464">
                <a:tc vMerge="1">
                  <a:txBody>
                    <a:bodyPr/>
                    <a:lstStyle/>
                    <a:p>
                      <a:pPr algn="ctr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l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Type 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43 (75.3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4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39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0.8 (86.3-95.4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9.2(79.2-99.2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333333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7.2 (94.5-99.9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70.2 (57.1-83.3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0.5 (86.4-94.7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20140757"/>
                  </a:ext>
                </a:extLst>
              </a:tr>
              <a:tr h="202464">
                <a:tc vMerge="1">
                  <a:txBody>
                    <a:bodyPr/>
                    <a:lstStyle/>
                    <a:p>
                      <a:pPr algn="ctr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l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Type 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 (0.5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00 (100.0-100.0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00 (100.0-100.0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00 (100.0-100.0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00 (100.0-100.0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00 (100.0-100.0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92102913"/>
                  </a:ext>
                </a:extLst>
              </a:tr>
              <a:tr h="202464">
                <a:tc vMerge="1">
                  <a:txBody>
                    <a:bodyPr/>
                    <a:lstStyle/>
                    <a:p>
                      <a:pPr algn="ctr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l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Total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90 (100)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36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53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77725986"/>
                  </a:ext>
                </a:extLst>
              </a:tr>
              <a:tr h="202464">
                <a:tc vMerge="1">
                  <a:txBody>
                    <a:bodyPr/>
                    <a:lstStyle/>
                    <a:p>
                      <a:pPr algn="ctr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Laser-</a:t>
                      </a:r>
                    </a:p>
                    <a:p>
                      <a:pPr algn="ctr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BLI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Type 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57 (26.3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54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7.1 (78.8-95.4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8.1 (95.9-100.2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4.7 (85.1-98.8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5.0 (78.2-94.7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4.0 (90.9-97.2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11404859"/>
                  </a:ext>
                </a:extLst>
              </a:tr>
              <a:tr h="202464">
                <a:tc vMerge="1">
                  <a:txBody>
                    <a:bodyPr/>
                    <a:lstStyle/>
                    <a:p>
                      <a:pPr algn="ctr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l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Type 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60 (73.7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52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8.1 (95.9-100.2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7.1 (78.8-95.4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5.0 (78.2-94.7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4.7 (85.1-98.8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4.0 (90.9-97.2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21102075"/>
                  </a:ext>
                </a:extLst>
              </a:tr>
              <a:tr h="202464">
                <a:tc vMerge="1">
                  <a:txBody>
                    <a:bodyPr/>
                    <a:lstStyle/>
                    <a:p>
                      <a:pPr algn="ctr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l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Type 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 (0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N/A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00 (100.0-100.0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N/A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00 (100.0-100.0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00 (100.0-100.0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16279717"/>
                  </a:ext>
                </a:extLst>
              </a:tr>
              <a:tr h="202464">
                <a:tc vMerge="1">
                  <a:txBody>
                    <a:bodyPr/>
                    <a:lstStyle/>
                    <a:p>
                      <a:pPr algn="ctr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l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Total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217 (100)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62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55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25562016"/>
                  </a:ext>
                </a:extLst>
              </a:tr>
              <a:tr h="202464">
                <a:tc vMerge="1">
                  <a:txBody>
                    <a:bodyPr/>
                    <a:lstStyle/>
                    <a:p>
                      <a:pPr algn="ctr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LED-</a:t>
                      </a:r>
                    </a:p>
                    <a:p>
                      <a:pPr algn="ctr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BLI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Type 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67 (35.6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48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9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0.6 (82.7-98.4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5.9 (80.1-91.8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71.6 (60.8-82.4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5.9 (92.3-99.4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7.2 (82.5-92.0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74521847"/>
                  </a:ext>
                </a:extLst>
              </a:tr>
              <a:tr h="202464">
                <a:tc vMerge="1">
                  <a:txBody>
                    <a:bodyPr/>
                    <a:lstStyle/>
                    <a:p>
                      <a:pPr algn="ctr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l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Type 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21 (64.4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5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16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5.9 (80.1-91.8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0.6 (82.7-98.4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5.9 (90.4-98.5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71.6 (60.8-82.4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7.2 (82.5-92.0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61658953"/>
                  </a:ext>
                </a:extLst>
              </a:tr>
              <a:tr h="202464">
                <a:tc vMerge="1">
                  <a:txBody>
                    <a:bodyPr/>
                    <a:lstStyle/>
                    <a:p>
                      <a:pPr algn="ctr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l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Type 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 (0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N/A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00 (100.0-100.0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N/A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00 (100.0-100.0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00 (100.0-100.0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21546076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pPr algn="ctr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vMerge="1">
                  <a:txBody>
                    <a:bodyPr/>
                    <a:lstStyle/>
                    <a:p>
                      <a:pPr algn="l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Total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88 (100)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53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35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5789749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97454841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 1">
            <a:extLst>
              <a:ext uri="{FF2B5EF4-FFF2-40B4-BE49-F238E27FC236}">
                <a16:creationId xmlns:a16="http://schemas.microsoft.com/office/drawing/2014/main" id="{29AB3240-50B4-47EC-934D-8264B9B460D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7884807"/>
              </p:ext>
            </p:extLst>
          </p:nvPr>
        </p:nvGraphicFramePr>
        <p:xfrm>
          <a:off x="250638" y="1878801"/>
          <a:ext cx="11690723" cy="1199388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403412">
                  <a:extLst>
                    <a:ext uri="{9D8B030D-6E8A-4147-A177-3AD203B41FA5}">
                      <a16:colId xmlns:a16="http://schemas.microsoft.com/office/drawing/2014/main" val="879600490"/>
                    </a:ext>
                  </a:extLst>
                </a:gridCol>
                <a:gridCol w="508000">
                  <a:extLst>
                    <a:ext uri="{9D8B030D-6E8A-4147-A177-3AD203B41FA5}">
                      <a16:colId xmlns:a16="http://schemas.microsoft.com/office/drawing/2014/main" val="1193865092"/>
                    </a:ext>
                  </a:extLst>
                </a:gridCol>
                <a:gridCol w="996950">
                  <a:extLst>
                    <a:ext uri="{9D8B030D-6E8A-4147-A177-3AD203B41FA5}">
                      <a16:colId xmlns:a16="http://schemas.microsoft.com/office/drawing/2014/main" val="590934235"/>
                    </a:ext>
                  </a:extLst>
                </a:gridCol>
                <a:gridCol w="857250">
                  <a:extLst>
                    <a:ext uri="{9D8B030D-6E8A-4147-A177-3AD203B41FA5}">
                      <a16:colId xmlns:a16="http://schemas.microsoft.com/office/drawing/2014/main" val="1909442611"/>
                    </a:ext>
                  </a:extLst>
                </a:gridCol>
                <a:gridCol w="546100">
                  <a:extLst>
                    <a:ext uri="{9D8B030D-6E8A-4147-A177-3AD203B41FA5}">
                      <a16:colId xmlns:a16="http://schemas.microsoft.com/office/drawing/2014/main" val="3050339693"/>
                    </a:ext>
                  </a:extLst>
                </a:gridCol>
                <a:gridCol w="596900">
                  <a:extLst>
                    <a:ext uri="{9D8B030D-6E8A-4147-A177-3AD203B41FA5}">
                      <a16:colId xmlns:a16="http://schemas.microsoft.com/office/drawing/2014/main" val="3343864707"/>
                    </a:ext>
                  </a:extLst>
                </a:gridCol>
                <a:gridCol w="622300">
                  <a:extLst>
                    <a:ext uri="{9D8B030D-6E8A-4147-A177-3AD203B41FA5}">
                      <a16:colId xmlns:a16="http://schemas.microsoft.com/office/drawing/2014/main" val="2288560281"/>
                    </a:ext>
                  </a:extLst>
                </a:gridCol>
                <a:gridCol w="673100">
                  <a:extLst>
                    <a:ext uri="{9D8B030D-6E8A-4147-A177-3AD203B41FA5}">
                      <a16:colId xmlns:a16="http://schemas.microsoft.com/office/drawing/2014/main" val="708647273"/>
                    </a:ext>
                  </a:extLst>
                </a:gridCol>
                <a:gridCol w="50800">
                  <a:extLst>
                    <a:ext uri="{9D8B030D-6E8A-4147-A177-3AD203B41FA5}">
                      <a16:colId xmlns:a16="http://schemas.microsoft.com/office/drawing/2014/main" val="3190960854"/>
                    </a:ext>
                  </a:extLst>
                </a:gridCol>
                <a:gridCol w="1244600">
                  <a:extLst>
                    <a:ext uri="{9D8B030D-6E8A-4147-A177-3AD203B41FA5}">
                      <a16:colId xmlns:a16="http://schemas.microsoft.com/office/drawing/2014/main" val="1036683323"/>
                    </a:ext>
                  </a:extLst>
                </a:gridCol>
                <a:gridCol w="1270000">
                  <a:extLst>
                    <a:ext uri="{9D8B030D-6E8A-4147-A177-3AD203B41FA5}">
                      <a16:colId xmlns:a16="http://schemas.microsoft.com/office/drawing/2014/main" val="1177727745"/>
                    </a:ext>
                  </a:extLst>
                </a:gridCol>
                <a:gridCol w="1231900">
                  <a:extLst>
                    <a:ext uri="{9D8B030D-6E8A-4147-A177-3AD203B41FA5}">
                      <a16:colId xmlns:a16="http://schemas.microsoft.com/office/drawing/2014/main" val="261929072"/>
                    </a:ext>
                  </a:extLst>
                </a:gridCol>
                <a:gridCol w="1155700">
                  <a:extLst>
                    <a:ext uri="{9D8B030D-6E8A-4147-A177-3AD203B41FA5}">
                      <a16:colId xmlns:a16="http://schemas.microsoft.com/office/drawing/2014/main" val="1639862295"/>
                    </a:ext>
                  </a:extLst>
                </a:gridCol>
                <a:gridCol w="1533711">
                  <a:extLst>
                    <a:ext uri="{9D8B030D-6E8A-4147-A177-3AD203B41FA5}">
                      <a16:colId xmlns:a16="http://schemas.microsoft.com/office/drawing/2014/main" val="51232554"/>
                    </a:ext>
                  </a:extLst>
                </a:gridCol>
              </a:tblGrid>
              <a:tr h="117198">
                <a:tc>
                  <a:txBody>
                    <a:bodyPr/>
                    <a:lstStyle/>
                    <a:p>
                      <a:pPr algn="l" fontAlgn="t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 gridSpan="4"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pathological findings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 gridSpan="5"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Diagnostic performance (%, 95% CI)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17963265"/>
                  </a:ext>
                </a:extLst>
              </a:tr>
              <a:tr h="229300">
                <a:tc>
                  <a:txBody>
                    <a:bodyPr/>
                    <a:lstStyle/>
                    <a:p>
                      <a:pPr algn="l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JNET classification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>
                          <a:effectLst/>
                          <a:latin typeface="+mn-lt"/>
                        </a:rPr>
                        <a:t>N (%)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HP/SSP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21917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LGD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21917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u="none" strike="noStrike" dirty="0">
                          <a:effectLst/>
                          <a:latin typeface="+mn-lt"/>
                        </a:rPr>
                        <a:t>HGD+</a:t>
                      </a:r>
                    </a:p>
                    <a:p>
                      <a:pPr marL="0" marR="0" lvl="0" indent="0" algn="ctr" defTabSz="121917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u="none" strike="noStrike" dirty="0">
                          <a:effectLst/>
                          <a:latin typeface="+mn-lt"/>
                        </a:rPr>
                        <a:t>s-SM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d-SM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u="none" strike="noStrike" dirty="0">
                          <a:effectLst/>
                          <a:latin typeface="+mn-lt"/>
                        </a:rPr>
                        <a:t>Sensitivity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u="none" strike="noStrike" dirty="0">
                          <a:effectLst/>
                          <a:latin typeface="+mn-lt"/>
                        </a:rPr>
                        <a:t>Specificity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>
                          <a:effectLst/>
                          <a:latin typeface="+mn-lt"/>
                        </a:rPr>
                        <a:t>PPV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>
                          <a:effectLst/>
                          <a:latin typeface="+mn-lt"/>
                        </a:rPr>
                        <a:t>NPV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>
                          <a:effectLst/>
                          <a:latin typeface="+mn-lt"/>
                        </a:rPr>
                        <a:t>Accuracy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53498123"/>
                  </a:ext>
                </a:extLst>
              </a:tr>
              <a:tr h="173249">
                <a:tc rowSpan="15">
                  <a:txBody>
                    <a:bodyPr/>
                    <a:lstStyle/>
                    <a:p>
                      <a:pPr marL="0" marR="0" lvl="0" indent="0" algn="ctr" defTabSz="121917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</a:rPr>
                        <a:t>Evaluator 1</a:t>
                      </a:r>
                    </a:p>
                  </a:txBody>
                  <a:tcPr marL="7620" marR="7620" marT="7620" marB="0" vert="vert27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rowSpan="5"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NBI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Type 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30 (16.1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27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2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77.1 (63.2-91.1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9.4 (98.1-100.6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0.0 (79.3-100.7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4.9 (91.4-98.3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4.1 (90.7-97.5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35806207"/>
                  </a:ext>
                </a:extLst>
              </a:tr>
              <a:tr h="17324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marL="0" marR="0" lvl="0" indent="0" algn="l" defTabSz="121917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21917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u="none" strike="noStrike" dirty="0">
                          <a:effectLst/>
                          <a:latin typeface="+mn-lt"/>
                        </a:rPr>
                        <a:t>Type 2</a:t>
                      </a: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A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14 (61.3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9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7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78.1 (70.5-85.7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65.3 (54.3-76.3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78.1 (70.5-85.7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65.3 (54.3-76.3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73.1 (66.7-79.5</a:t>
                      </a:r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）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19229473"/>
                  </a:ext>
                </a:extLst>
              </a:tr>
              <a:tr h="17324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l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Type 2B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40 (21.5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23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7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47.2 (30.9-63.5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4.7 (78.9-90.4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42.5 (27.2-57.8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7.0 (81.5-92.4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77.4 (71.4-83.4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3911770"/>
                  </a:ext>
                </a:extLst>
              </a:tr>
              <a:tr h="17324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l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Type 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2 (1.1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00 (100.0-100.0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9.5 (98.4-100.5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50.0 (-19.3-119.3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00 (100.0-100.0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9.5 (98.4-100.5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9186977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l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Total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86 (100)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35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14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36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95857064"/>
                  </a:ext>
                </a:extLst>
              </a:tr>
              <a:tr h="173249">
                <a:tc vMerge="1">
                  <a:txBody>
                    <a:bodyPr/>
                    <a:lstStyle/>
                    <a:p>
                      <a:pPr algn="ctr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5"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Laser-</a:t>
                      </a:r>
                    </a:p>
                    <a:p>
                      <a:pPr algn="ctr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BLI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Type 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52 (25.6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49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79.0 (68.9-89.2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7.2 (94.5-99.9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4.2 (87.9-100.6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1.4 (86.9-95.9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2.1 (88.4-95.8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30656366"/>
                  </a:ext>
                </a:extLst>
              </a:tr>
              <a:tr h="17324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marL="0" marR="0" lvl="0" indent="0" algn="l" defTabSz="121917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21917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u="none" strike="noStrike" dirty="0">
                          <a:effectLst/>
                          <a:latin typeface="+mn-lt"/>
                        </a:rPr>
                        <a:t>Type 2</a:t>
                      </a: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A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20 (59.1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3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3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4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3.8(76.9-90.6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70.7 (61.3-80.0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333333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77.5 (70.0-85.0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78.3 (69.4-87.2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77.8 (72.1-83.5</a:t>
                      </a:r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）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1195115"/>
                  </a:ext>
                </a:extLst>
              </a:tr>
              <a:tr h="17324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l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Type 2B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29 (14.3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4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5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50.0 (32.1-67.9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1.3 (87.1-95.5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51.7 (33.5-69.9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1.4 (87.2-95.5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5.7 (80.9-90.5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69580267"/>
                  </a:ext>
                </a:extLst>
              </a:tr>
              <a:tr h="17324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l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Type 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2 (1.0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N/A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9.0 (97.7-100.4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 (0.0-0.0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00 (100.0-100.0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9.0 (97.7-100.4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47963851"/>
                  </a:ext>
                </a:extLst>
              </a:tr>
              <a:tr h="17324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l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Total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203 (100)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62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11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30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18123244"/>
                  </a:ext>
                </a:extLst>
              </a:tr>
              <a:tr h="173249">
                <a:tc vMerge="1">
                  <a:txBody>
                    <a:bodyPr/>
                    <a:lstStyle/>
                    <a:p>
                      <a:pPr algn="ctr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5"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LED-</a:t>
                      </a:r>
                    </a:p>
                    <a:p>
                      <a:pPr algn="ctr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BLI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Type 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46 (27.9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37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4.1 (73.3-94.9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2.6 (87.9-97.2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0.4 (69.0-91.9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4.4 (90.6-98.2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0.3 (85.8-94.8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5238358"/>
                  </a:ext>
                </a:extLst>
              </a:tr>
              <a:tr h="17324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marL="0" marR="0" lvl="0" indent="0" algn="l" defTabSz="121917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21917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u="none" strike="noStrike" dirty="0">
                          <a:effectLst/>
                          <a:latin typeface="+mn-lt"/>
                        </a:rPr>
                        <a:t>Type 2</a:t>
                      </a: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A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9 (60.0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7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76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6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79.2 (71.0-87.3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66.7 (55.5-77.8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333333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76.8 (68.4-85.1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69.7 (58.6-80.8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73.9 (67.2-80.6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91339618"/>
                  </a:ext>
                </a:extLst>
              </a:tr>
              <a:tr h="17324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l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Type 2B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20 (12.1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1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36.0 (17.2-54.8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2.1 (87.7-96.6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45.0 (23.2-66.8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9.0 (83.9-94.1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3.6 (78.0-89.3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40100904"/>
                  </a:ext>
                </a:extLst>
              </a:tr>
              <a:tr h="17324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l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Type 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 (0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N/A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00 (100.0-100.0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N/A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00 (100.0-100.0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00 (100.0-100.0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68536819"/>
                  </a:ext>
                </a:extLst>
              </a:tr>
              <a:tr h="17324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l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Total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65 (100)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44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6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25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56819661"/>
                  </a:ext>
                </a:extLst>
              </a:tr>
              <a:tr h="173249">
                <a:tc rowSpan="15">
                  <a:txBody>
                    <a:bodyPr/>
                    <a:lstStyle/>
                    <a:p>
                      <a:pPr marL="0" marR="0" lvl="0" indent="0" algn="ctr" defTabSz="121917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</a:rPr>
                        <a:t>Evaluator 2</a:t>
                      </a:r>
                    </a:p>
                  </a:txBody>
                  <a:tcPr marL="7620" marR="7620" marT="7620" marB="0" vert="vert27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5"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NBI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Type 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27 (14.1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26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74.3 (59.8-88.8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9.4 (96.1-100.2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6.3 (89.2-103.4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4.5 (91.1-98.0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4.8 (91.6-97.9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82843503"/>
                  </a:ext>
                </a:extLst>
              </a:tr>
              <a:tr h="17324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marL="0" marR="0" lvl="0" indent="0" algn="l" defTabSz="121917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21917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u="none" strike="noStrike" dirty="0">
                          <a:effectLst/>
                          <a:latin typeface="+mn-lt"/>
                        </a:rPr>
                        <a:t>Type 2</a:t>
                      </a: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A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29 (67.2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6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24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2.1 (75.1-89.0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56.0 (44.8-67.2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333333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2.1 (75.1-89.0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66.7 (55.0-78.3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71.9 (65.5-78.2</a:t>
                      </a:r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）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29222437"/>
                  </a:ext>
                </a:extLst>
              </a:tr>
              <a:tr h="17324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l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Type 2B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35 (18.2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2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4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35.9 (20.8-51.0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6.3 (80.8-91.7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40.0 (23.8-56.2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4.1 (78.4-89.8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76.0 (70.0-82.1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59046623"/>
                  </a:ext>
                </a:extLst>
              </a:tr>
              <a:tr h="17324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l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Type 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 (0.5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 (0.0-0.0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9.5 (98.5-100.5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 (0.0-0.0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9.5 (98.5-100.5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9.0 (97.5-100.4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24698510"/>
                  </a:ext>
                </a:extLst>
              </a:tr>
              <a:tr h="17324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l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Total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92 (100)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35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17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39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42373445"/>
                  </a:ext>
                </a:extLst>
              </a:tr>
              <a:tr h="173249">
                <a:tc vMerge="1">
                  <a:txBody>
                    <a:bodyPr/>
                    <a:lstStyle/>
                    <a:p>
                      <a:pPr algn="ctr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5"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Laser-</a:t>
                      </a:r>
                    </a:p>
                    <a:p>
                      <a:pPr algn="ctr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BLI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Type 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54 (24.3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51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2.3 (72.7-91.8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8.1 (96.0-100.2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4.4 (88.3-100.6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3.5 (89.7-97.2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3.7 (90.5-96.9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78144522"/>
                  </a:ext>
                </a:extLst>
              </a:tr>
              <a:tr h="17324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marL="0" marR="0" lvl="0" indent="0" algn="l" defTabSz="121917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21917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u="none" strike="noStrike" dirty="0">
                          <a:effectLst/>
                          <a:latin typeface="+mn-lt"/>
                        </a:rPr>
                        <a:t>Type 2</a:t>
                      </a: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A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39 (62.6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1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07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21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4.9 (78.7-91.2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66.7 (57.2-76.1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333333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77.0 (70.0-84.0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77.1 (68.1-86.1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77.0 (71.5-82.6</a:t>
                      </a:r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）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24503389"/>
                  </a:ext>
                </a:extLst>
              </a:tr>
              <a:tr h="17324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l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Type 2B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29 (13.1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6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3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38.2 (21.9-54.6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1.5 (87.5-95.5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44.8 (26.7-62.9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9.1 (84.7-93.5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3.3 (78.4-88.2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88648146"/>
                  </a:ext>
                </a:extLst>
              </a:tr>
              <a:tr h="17324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l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Type 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 (0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N/A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00 (100.0-100.0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N/A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00 (100.0-100.0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00 (100.0-100.0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82281613"/>
                  </a:ext>
                </a:extLst>
              </a:tr>
              <a:tr h="17324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l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Total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222 (100)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62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26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34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22789110"/>
                  </a:ext>
                </a:extLst>
              </a:tr>
              <a:tr h="173249">
                <a:tc vMerge="1">
                  <a:txBody>
                    <a:bodyPr/>
                    <a:lstStyle/>
                    <a:p>
                      <a:pPr algn="ctr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5"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LED-</a:t>
                      </a:r>
                    </a:p>
                    <a:p>
                      <a:pPr algn="ctr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BLI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Type 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46 (24.3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41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5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3.7 (73.3-94.0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6.4 (93.4-99.5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9.1 (80.1-98.1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4.4 (90.6-98.2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3.1 (89.5-96.7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47103087"/>
                  </a:ext>
                </a:extLst>
              </a:tr>
              <a:tr h="17324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marL="0" marR="0" lvl="0" indent="0" algn="l" defTabSz="121917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21917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u="none" strike="noStrike" dirty="0">
                          <a:effectLst/>
                          <a:latin typeface="+mn-lt"/>
                        </a:rPr>
                        <a:t>Type 2</a:t>
                      </a: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A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23 (65.1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7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8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8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9.1 (83.3-94.9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68.4(58.1-78.6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333333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79.7 (72.6-86.8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1.8 (72.5-91.1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0.4 (74.8-86.1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26864531"/>
                  </a:ext>
                </a:extLst>
              </a:tr>
              <a:tr h="17324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l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Type 2B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20 (10.6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7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2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40.0 (22.5-57.5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5.0 (91.6-98.4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60.0 (38.5-81.5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9.3 (84.7-94.0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6.2 (81.3-91.2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07955308"/>
                  </a:ext>
                </a:extLst>
              </a:tr>
              <a:tr h="17324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l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Type 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 (0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N/A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00 (100.0-100.0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N/A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00 (100.0-100.0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00 (100.0-100.0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4647396"/>
                  </a:ext>
                </a:extLst>
              </a:tr>
              <a:tr h="17324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l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Total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89 (100)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49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10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30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51668584"/>
                  </a:ext>
                </a:extLst>
              </a:tr>
              <a:tr h="173249">
                <a:tc rowSpan="15">
                  <a:txBody>
                    <a:bodyPr/>
                    <a:lstStyle/>
                    <a:p>
                      <a:pPr marL="0" marR="0" lvl="0" indent="0" algn="ctr" defTabSz="121917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</a:rPr>
                        <a:t>Evaluator 3</a:t>
                      </a:r>
                    </a:p>
                  </a:txBody>
                  <a:tcPr marL="7620" marR="7620" marT="7620" marB="0" vert="vert27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5"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NBI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Type 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30 (15.6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28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0.0 (67.7-93.3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8.7 (97.0-100.5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3.3 (84.4-102.3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5.7 (92.5-98.8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5.3 (92.3-98.3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58441576"/>
                  </a:ext>
                </a:extLst>
              </a:tr>
              <a:tr h="17324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marL="0" marR="0" lvl="0" indent="0" algn="l" defTabSz="121917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21917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u="none" strike="noStrike" dirty="0">
                          <a:effectLst/>
                          <a:latin typeface="+mn-lt"/>
                        </a:rPr>
                        <a:t>Type 2</a:t>
                      </a: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A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16 (60.4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7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2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7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78.6 (71.2-86.1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68.0 (57.4-78.6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333333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79.3 (71.9-86.7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67.1 (56.5-77.7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74.5 (68.3-80.6</a:t>
                      </a:r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）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88589133"/>
                  </a:ext>
                </a:extLst>
              </a:tr>
              <a:tr h="17324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l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Type 2B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45 (23.4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24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2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51.3 (35.6-67.0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3.7 (77.8-89.5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44.4 (29.9-59.0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7.1 (81.7-92.5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77.1 (71.1-83.0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76696234"/>
                  </a:ext>
                </a:extLst>
              </a:tr>
              <a:tr h="17324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l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Type 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 (0.5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 (0.0-0.0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9.5 (98.5-100.5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 (0.0-0.0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9.5 (98.5-100.5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9.0 (97.5-100.4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19350218"/>
                  </a:ext>
                </a:extLst>
              </a:tr>
              <a:tr h="17324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l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Total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92 (100)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35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17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39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13783662"/>
                  </a:ext>
                </a:extLst>
              </a:tr>
              <a:tr h="173249">
                <a:tc vMerge="1">
                  <a:txBody>
                    <a:bodyPr/>
                    <a:lstStyle/>
                    <a:p>
                      <a:pPr algn="ctr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5"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Laser-</a:t>
                      </a:r>
                    </a:p>
                    <a:p>
                      <a:pPr algn="ctr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BLI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Type 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54 (24.4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49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5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79.0 (68.9-89.2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6.9 (94.1-99.6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0.7 (83.0-98.5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2.2 (88.2-96.3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1.9 (88.2-95.5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01255923"/>
                  </a:ext>
                </a:extLst>
              </a:tr>
              <a:tr h="17324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marL="0" marR="0" lvl="0" indent="0" algn="l" defTabSz="121917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21917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u="none" strike="noStrike" dirty="0">
                          <a:effectLst/>
                          <a:latin typeface="+mn-lt"/>
                        </a:rPr>
                        <a:t>Type 2</a:t>
                      </a: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A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12 (50.7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3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4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5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67.2 (59.0-75.4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72.4 (60.3-78.5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333333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75.0 (67.0-83.0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62.4 (53.3-71.5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68.8 (62.7-74.9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51592449"/>
                  </a:ext>
                </a:extLst>
              </a:tr>
              <a:tr h="17324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l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Type 2B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53 (24.0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34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9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55.9 (39.2-72.6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1.8 (76.3-87.3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35.8 (22.9-48.8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1.1 (86.8-95.4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77.8 (72.4-83.3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03667573"/>
                  </a:ext>
                </a:extLst>
              </a:tr>
              <a:tr h="17324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l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Type 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2 (0.9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2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N/A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9.1 (97.8-100.3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 (0.0-0.0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00 (100.0-100.0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9.1 (97.8-100.3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69124454"/>
                  </a:ext>
                </a:extLst>
              </a:tr>
              <a:tr h="17324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l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Total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221 (100)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62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25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34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67589306"/>
                  </a:ext>
                </a:extLst>
              </a:tr>
              <a:tr h="173249">
                <a:tc vMerge="1">
                  <a:txBody>
                    <a:bodyPr/>
                    <a:lstStyle/>
                    <a:p>
                      <a:pPr algn="ctr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5"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LED-</a:t>
                      </a:r>
                    </a:p>
                    <a:p>
                      <a:pPr algn="ctr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BLI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Type 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48 (25.7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39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3.0 (72.2-93.7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3.6 (89.5-97.6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1.3 70.2-92.3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4.2 (90.4-98.1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0.9 (86.8-95.0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88174341"/>
                  </a:ext>
                </a:extLst>
              </a:tr>
              <a:tr h="17324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marL="0" marR="0" lvl="0" indent="0" algn="l" defTabSz="121917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21917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u="none" strike="noStrike" dirty="0">
                          <a:effectLst/>
                          <a:latin typeface="+mn-lt"/>
                        </a:rPr>
                        <a:t>Type 2</a:t>
                      </a: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A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03 (55.1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5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72.7 (64.4-81.1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70.1 (59.9-80.4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333333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77.7 (69.6-85.7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64.3 (54.0-74.5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71.7 (65.2-78.1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02664382"/>
                  </a:ext>
                </a:extLst>
              </a:tr>
              <a:tr h="17324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l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Type 2B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36 (19.3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21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5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50.0 (32.1-67.9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6.6 (81.3-91.9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41.7 (25.6-57.8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0.1 (85.3-94.8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0.7 (75.1-86.4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60309278"/>
                  </a:ext>
                </a:extLst>
              </a:tr>
              <a:tr h="17324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l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Type 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 (0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N/A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00 (100.0-100.0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N/A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00 (100.0-100.0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00 (100.0-100.0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53774822"/>
                  </a:ext>
                </a:extLst>
              </a:tr>
              <a:tr h="17324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vMerge="1">
                  <a:txBody>
                    <a:bodyPr/>
                    <a:lstStyle/>
                    <a:p>
                      <a:pPr algn="l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Total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87 (100)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47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10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30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13423603"/>
                  </a:ext>
                </a:extLst>
              </a:tr>
              <a:tr h="173249">
                <a:tc rowSpan="15">
                  <a:txBody>
                    <a:bodyPr/>
                    <a:lstStyle/>
                    <a:p>
                      <a:pPr marL="0" marR="0" lvl="0" indent="0" algn="ctr" defTabSz="121917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</a:rPr>
                        <a:t>Evaluator 4</a:t>
                      </a:r>
                    </a:p>
                  </a:txBody>
                  <a:tcPr marL="7620" marR="7620" marT="7620" marB="0" vert="vert27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5"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NBI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Type 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36 (18.9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30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5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5.7 (74.1-97.3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6.1 (93.1-99.2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3.3 (71.2-95.5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6.8 (94.0-99.6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4.2 (90.9-97.5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06250815"/>
                  </a:ext>
                </a:extLst>
              </a:tr>
              <a:tr h="17324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marL="0" marR="0" lvl="0" indent="0" algn="l" defTabSz="121917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21917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u="none" strike="noStrike" dirty="0">
                          <a:effectLst/>
                          <a:latin typeface="+mn-lt"/>
                        </a:rPr>
                        <a:t>Type 2</a:t>
                      </a: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A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20 (63.2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5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02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3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7.2 (81.1-93.2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75.3 (65.5-85.2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333333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5.0 (78.6-91.4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78.6 (69.0-88.2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2.6 (77.2-88.0</a:t>
                      </a:r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）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14559814"/>
                  </a:ext>
                </a:extLst>
              </a:tr>
              <a:tr h="17324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l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Type 2B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31 (16.3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21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56.8 (40.8-72.7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3.5 (89.5-97.4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67.7 (51.3-84.2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9.9 (85.3-94.6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6.3 (81.4-91.2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50740848"/>
                  </a:ext>
                </a:extLst>
              </a:tr>
              <a:tr h="17324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l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Type 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3 (1.6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2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00 (100.0-100.0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8.9 (97.5-100.4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33.3 (-20.0-86.7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00 (100.0-100.0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8.9 (97.5-100.4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58228513"/>
                  </a:ext>
                </a:extLst>
              </a:tr>
              <a:tr h="17324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l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Total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90 (100)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35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17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37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42361852"/>
                  </a:ext>
                </a:extLst>
              </a:tr>
              <a:tr h="173249">
                <a:tc vMerge="1">
                  <a:txBody>
                    <a:bodyPr/>
                    <a:lstStyle/>
                    <a:p>
                      <a:pPr algn="ctr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5"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Laser-</a:t>
                      </a:r>
                    </a:p>
                    <a:p>
                      <a:pPr algn="ctr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BLI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Type 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57 (26.0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51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6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3.6 (74.3-92.9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6.2 (93.2-99.2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9.5 (81.5-97.4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3.8 (90.1-97.5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2.7 (89.2-96.1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95302173"/>
                  </a:ext>
                </a:extLst>
              </a:tr>
              <a:tr h="17324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marL="0" marR="0" lvl="0" indent="0" algn="l" defTabSz="121917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21917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u="none" strike="noStrike" dirty="0">
                          <a:effectLst/>
                          <a:latin typeface="+mn-lt"/>
                        </a:rPr>
                        <a:t>Type 2</a:t>
                      </a: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A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41 (64.4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07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24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4.9 (78.7-91.2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62.4 (52.5-72.2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333333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75.9 (68.8-82.9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74.4 (64.7-84.0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75.3 (69.6-81.1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11342210"/>
                  </a:ext>
                </a:extLst>
              </a:tr>
              <a:tr h="17324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l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Type 2B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20 (9.1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3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7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21.9 (7.6-36.2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3.0 (89.4-96.7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35.0 (14.1-55.9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7.4 (82.8-92.0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2.6 (77.6-87.7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10197655"/>
                  </a:ext>
                </a:extLst>
              </a:tr>
              <a:tr h="17324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l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Type 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 (0.5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N/A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9.5 (98.7-100.4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 (0.0-0.0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00 (100.0-100.0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9.5 (98.7-100.4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60320436"/>
                  </a:ext>
                </a:extLst>
              </a:tr>
              <a:tr h="17324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l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Total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219 (100)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61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26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32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72530826"/>
                  </a:ext>
                </a:extLst>
              </a:tr>
              <a:tr h="173249">
                <a:tc vMerge="1">
                  <a:txBody>
                    <a:bodyPr/>
                    <a:lstStyle/>
                    <a:p>
                      <a:pPr algn="ctr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5"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LED-</a:t>
                      </a:r>
                    </a:p>
                    <a:p>
                      <a:pPr algn="ctr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BLI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Type 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55 (29.6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42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3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9.4 (80.5-98.2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0.6 (85.8-95.5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76.4 (65.1-87.6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6.2 (92.9-99.5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0.3 (86.1-94.6)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71533936"/>
                  </a:ext>
                </a:extLst>
              </a:tr>
              <a:tr h="17324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marL="0" marR="0" lvl="0" indent="0" algn="l" defTabSz="121917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21917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u="none" strike="noStrike" dirty="0">
                          <a:effectLst/>
                          <a:latin typeface="+mn-lt"/>
                        </a:rPr>
                        <a:t>Type 2</a:t>
                      </a: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A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15 (61.8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5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2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8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3.6 (76.7-90.5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69.7 (59.4-80.1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333333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0.0 (82.7-87.3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74.6 (64.5-84.8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76.9 (70.8-82.9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09509724"/>
                  </a:ext>
                </a:extLst>
              </a:tr>
              <a:tr h="17324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l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Type 2B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6 (8.6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5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1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37.9 (20.3-55.6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96.8 (94.1-99.6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68.8 (46.0-91.5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2.3 (76.8-87.7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7.6 (82.9-92.4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66741164"/>
                  </a:ext>
                </a:extLst>
              </a:tr>
              <a:tr h="17324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l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Type 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 (0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N/A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00 (100.0-100.0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N/A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00 (100.0-100.0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00 (100.0-100.0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31658512"/>
                  </a:ext>
                </a:extLst>
              </a:tr>
              <a:tr h="17324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vMerge="1">
                  <a:txBody>
                    <a:bodyPr/>
                    <a:lstStyle/>
                    <a:p>
                      <a:pPr algn="l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Total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86 (100)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47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10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29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0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ja-JP" altLang="en-US" sz="12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1926911"/>
                  </a:ext>
                </a:extLst>
              </a:tr>
            </a:tbl>
          </a:graphicData>
        </a:graphic>
      </p:graphicFrame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DF890955-DC3A-4E2C-B7BD-ADC2F205A9F5}"/>
              </a:ext>
            </a:extLst>
          </p:cNvPr>
          <p:cNvSpPr txBox="1"/>
          <p:nvPr/>
        </p:nvSpPr>
        <p:spPr>
          <a:xfrm>
            <a:off x="907559" y="922650"/>
            <a:ext cx="10633873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Table 2</a:t>
            </a:r>
          </a:p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lationship between JNET classification and pathological findings, diagnostic performance of NBI, Laser-BLI </a:t>
            </a:r>
          </a:p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LED-BLI </a:t>
            </a:r>
            <a:r>
              <a:rPr lang="en-US" altLang="ja-JP" sz="18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results of each four evaluator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152452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9243</TotalTime>
  <Words>3388</Words>
  <Application>Microsoft Office PowerPoint</Application>
  <PresentationFormat>ユーザー設定</PresentationFormat>
  <Paragraphs>1303</Paragraphs>
  <Slides>4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11" baseType="lpstr">
      <vt:lpstr>游ゴシック</vt:lpstr>
      <vt:lpstr>Arial</vt:lpstr>
      <vt:lpstr>Calibri</vt:lpstr>
      <vt:lpstr>Calibri Light</vt:lpstr>
      <vt:lpstr>Century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junarimoto_junjun</dc:creator>
  <cp:lastModifiedBy>琢磨</cp:lastModifiedBy>
  <cp:revision>164</cp:revision>
  <dcterms:created xsi:type="dcterms:W3CDTF">2018-12-27T07:34:52Z</dcterms:created>
  <dcterms:modified xsi:type="dcterms:W3CDTF">2021-09-02T22:00:22Z</dcterms:modified>
</cp:coreProperties>
</file>